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svg" ContentType="image/svg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  <p:sldId id="257" r:id="rId3"/>
    <p:sldId id="258" r:id="rId4"/>
    <p:sldId id="259" r:id="rId5"/>
    <p:sldId id="260" r:id="rId6"/>
    <p:sldId id="261" r:id="rId7"/>
    <p:sldId id="262" r:id="rId8"/>
  </p:sldIdLst>
  <p:sldSz cx="12192000" cy="6858000"/>
  <p:notesSz cx="6858000" cy="9144000"/>
  <p:defaultTextStyle>
    <a:defPPr>
      <a:defRPr lang="en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50"/>
  </p:normalViewPr>
  <p:slideViewPr>
    <p:cSldViewPr snapToGrid="0">
      <p:cViewPr varScale="1">
        <p:scale>
          <a:sx n="120" d="100"/>
          <a:sy n="120" d="100"/>
        </p:scale>
        <p:origin x="25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9142E1-A477-3E0F-CF39-3C3EC2F41F64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429C833C-3B4B-4AE0-08B3-27812D831E6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EF1CDD91-66AC-82CD-36F0-6AE2D027D8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548AD71-668A-5E42-1B60-08779A4FFB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9170F4C-6070-B976-5B91-E53093E715E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789722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5037F26-4A54-1256-A930-A1ADC538FB3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9B2F0E8-B287-86DC-1E87-00EB865E799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980D4D2-AFBB-3B57-2F5A-9306E226FDE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573860F-AF55-44E6-9F6F-780EE57B5D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8AEE87-2D04-33D0-2215-0393002B8E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1432406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79C999A5-0085-514A-3C2D-89F0178D514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ACF48EE-64AE-62EE-108A-D76C77755E86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5056CAC-D0BF-4470-41BD-4DF25030012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44C1F13-A9BB-DEAA-433A-BC09AF2189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D6F19C3-95B0-457F-AE0F-6F6567187D6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03432104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58DC76B-75DE-0637-D031-BBC9ACC9A74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D63781D-77C0-F7D1-64C5-3A8E4A92A53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39344FB-561D-B47C-5938-311D8CBB90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C9C2C7E-F519-DA96-9F44-8A159A4FBB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D97AD1B-5D95-0F6D-69D3-116A20952DE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92039496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54A245-3EBA-DADB-05B0-BF825287A4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0D2015C-01EA-5E3F-81A2-74AE3953DD9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8EE2D31-AE4B-32D3-658D-1DFFEB9B830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60DAF8E-3FFF-D62F-89FF-D44C3DC8895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65F9D7E-168A-4FD8-F30A-7F2BDA79BF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1037819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882ACF-651A-5F86-DE1B-8F5A2955176C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9E9DE08-C1E7-BBDB-77FB-9E2036E5FC0A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935F72D-2413-3D44-6B15-61E97E2D925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06164FE6-8748-1F67-CA55-0715E98FAB9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F0BE03F-D405-4DAA-361A-5AA452F4E8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64A4317-B63D-6210-21D3-B916B8F4BC5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78498387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C5E926-A56D-2501-DDC9-C2CB3F659B0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82C4584-BE61-3F43-DCEF-ECC3AD7B6A5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989B82FF-EBCE-BB0D-32FD-490337F50310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EDF25D3-F1B5-1399-CC26-1FEED61F60B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64EC858A-2DE7-ADE9-4006-58F7F12F87A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3126389-BBAC-478A-E6A7-54C4DF0CF55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431D98A2-CCAC-C173-CBE9-0F9B655309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EC94075F-F996-D155-D1CE-E2D5CFB21D7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51145304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CE2A47-76ED-5760-C0D7-1CAF1CEA305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128C487A-4539-2CF3-1D0F-AC5E88AF7B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C7F93875-6ECC-C042-247A-B1308FDDDBC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B1A08D4C-A303-8C33-639A-48EA9F3EE4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500050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15F84C77-3BF2-D270-B663-6120487D99C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0DC1E33-3B2A-D5AE-CE36-8AE8982F5D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B2C2CE91-46AF-C5DF-4CA2-0A122E6802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316961240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5A43C4-7551-F855-6A3C-87BA6E0D01F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8205132-044B-4936-AE6B-297812FE27E2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468C037-841A-21D9-F05F-50F3CEB9C9A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FA3999E-5158-71E6-CDDF-5812C7C2263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D347F7A-5DEE-2F0A-46BE-D19086FBE2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E0B90F4-4FF1-41BE-1D8A-FDFD9DD7054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5449728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9749E5A-3021-AA56-C46B-6548D880950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E69B41C5-5DA4-57E0-E781-B875CB176711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N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51AF7069-2A6F-9B7F-B3B3-C981500ECDC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09D8CF-CD86-3EAB-6B6D-F0F20A3AA5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9F0000F-BA5E-F63B-BF47-2BEC4DDD92A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N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F68A5BA-1B09-FC86-E338-DAB842218C7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25880161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413F3AF0-C8FD-54E5-F47B-2263D988663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N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E5569A3-230A-FBAC-01AD-690CAFEFD4E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N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7ECBFC-EF86-A95C-E93B-6616760DB08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DEE8BA8A-7950-AE43-ADC8-0111D95CFBF6}" type="datetimeFigureOut">
              <a:rPr lang="en-CN" smtClean="0"/>
              <a:t>2025/2/24</a:t>
            </a:fld>
            <a:endParaRPr lang="en-CN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02BA6C2-0060-8705-676C-0EE2A142810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CN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4768098-C1C6-AB17-7447-57DCC2969C7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9F219EB7-50F0-9F48-BEE6-AC4E67384A22}" type="slidenum">
              <a:rPr lang="en-CN" smtClean="0"/>
              <a:t>‹#›</a:t>
            </a:fld>
            <a:endParaRPr lang="en-CN"/>
          </a:p>
        </p:txBody>
      </p:sp>
    </p:spTree>
    <p:extLst>
      <p:ext uri="{BB962C8B-B14F-4D97-AF65-F5344CB8AC3E}">
        <p14:creationId xmlns:p14="http://schemas.microsoft.com/office/powerpoint/2010/main" val="13491203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f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5.svg"/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7.svg"/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ollage of ultrasound images&#10;&#10;Description automatically generated">
            <a:extLst>
              <a:ext uri="{FF2B5EF4-FFF2-40B4-BE49-F238E27FC236}">
                <a16:creationId xmlns:a16="http://schemas.microsoft.com/office/drawing/2014/main" id="{B2C7C49B-79E9-0BE5-E99A-10F3F5DC2DD6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773255" y="258444"/>
            <a:ext cx="8645489" cy="3956368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0DE2C496-9100-2758-98F8-E5082DC80C94}"/>
              </a:ext>
            </a:extLst>
          </p:cNvPr>
          <p:cNvSpPr txBox="1"/>
          <p:nvPr/>
        </p:nvSpPr>
        <p:spPr>
          <a:xfrm>
            <a:off x="1773255" y="4471987"/>
            <a:ext cx="8645489" cy="16546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 (Body CS)"/>
              </a:rPr>
              <a:t>Supplementary Fig. 1. Different surgical results of thyroid adenomatoid nodules on 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 (Body CS)"/>
              </a:rPr>
              <a:t>Ultrasound. A: Female, 45y, Nodular goiter. B: Male, 35y, follicular thyroid adenoma. 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 (Body CS)"/>
              </a:rPr>
              <a:t>C: Male, 52y, papillary thyroid carcinoma. D: Male, 54y, follicular thyroid carcinoma. 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 (Body CS)"/>
              </a:rPr>
              <a:t>E: Female, 34y, follicular variant papillary. F: Female, 65y, medullary carcinoma.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430130734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lose-up of a ultrasound&#10;&#10;Description automatically generated">
            <a:extLst>
              <a:ext uri="{FF2B5EF4-FFF2-40B4-BE49-F238E27FC236}">
                <a16:creationId xmlns:a16="http://schemas.microsoft.com/office/drawing/2014/main" id="{8EB8097D-5316-8458-B84A-4075B0EC9BEB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2666" y="709502"/>
            <a:ext cx="11271517" cy="296238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E0955BE-6247-76CD-E263-68A16BEC8C0A}"/>
              </a:ext>
            </a:extLst>
          </p:cNvPr>
          <p:cNvSpPr txBox="1"/>
          <p:nvPr/>
        </p:nvSpPr>
        <p:spPr>
          <a:xfrm>
            <a:off x="719921" y="3786188"/>
            <a:ext cx="1124426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Supplementary Fig. 2 Radiomics feature extraction. (A) Ultrasound conventional B-mode image of thyroid nodules. (B) Corresponding ultrasound image indicating a lesion region. (C) Corresponding image after region of interest (ROIs) segmentation step.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97529344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72CDBF7C-D7E7-BB7C-6B59-4FDB6BC7677F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896015" y="450651"/>
            <a:ext cx="10651840" cy="34641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0A17618-735D-954D-6E9E-C167EEAFDBF6}"/>
              </a:ext>
            </a:extLst>
          </p:cNvPr>
          <p:cNvSpPr txBox="1"/>
          <p:nvPr/>
        </p:nvSpPr>
        <p:spPr>
          <a:xfrm>
            <a:off x="896015" y="4129088"/>
            <a:ext cx="10787062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 (Body CS)"/>
              </a:rPr>
              <a:t>Supplementary Fig.3 The pathological or follow-up results of all TANUs. NG: Nodular goiter; FTA: Follicular thyroid adenoma; FTC: Follicular thyroid carcinoma; FVPTC: Follicular variant papillary thyroid carcinoma; PTC: Papillary thyroid carcinoma (PTC); MC: Medullary carcinoma (MC).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7639904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1">
            <a:extLst>
              <a:ext uri="{FF2B5EF4-FFF2-40B4-BE49-F238E27FC236}">
                <a16:creationId xmlns:a16="http://schemas.microsoft.com/office/drawing/2014/main" id="{3DFDD05A-64A0-D98D-3982-2C14320B2C4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2351730" y="393891"/>
            <a:ext cx="6577958" cy="4570763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4E8472F8-58A0-CA7C-2CC8-23E9A243F4C3}"/>
              </a:ext>
            </a:extLst>
          </p:cNvPr>
          <p:cNvSpPr txBox="1"/>
          <p:nvPr/>
        </p:nvSpPr>
        <p:spPr>
          <a:xfrm>
            <a:off x="3012640" y="4964654"/>
            <a:ext cx="5256138" cy="3911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15000"/>
              </a:lnSpc>
              <a:spcAft>
                <a:spcPts val="800"/>
              </a:spcAft>
            </a:pPr>
            <a:r>
              <a:rPr lang="en-US" sz="1800" kern="100" dirty="0">
                <a:effectLst/>
                <a:latin typeface="Times New Roman" panose="02020603050405020304" pitchFamily="18" charset="0"/>
                <a:ea typeface="DengXian" panose="02010600030101010101" pitchFamily="2" charset="-122"/>
                <a:cs typeface="Times New Roman (Body CS)"/>
              </a:rPr>
              <a:t>Supplementary Fig. 4 Statistics of radiomics features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63914612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Graphic 1">
            <a:extLst>
              <a:ext uri="{FF2B5EF4-FFF2-40B4-BE49-F238E27FC236}">
                <a16:creationId xmlns:a16="http://schemas.microsoft.com/office/drawing/2014/main" id="{4A86C9C8-BABD-8113-0E17-56F92403F891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  <a:ext uri="{96DAC541-7B7A-43D3-8B79-37D633B846F1}">
                <asvg:svgBlip xmlns:asvg="http://schemas.microsoft.com/office/drawing/2016/SVG/main" r:embed="rId3"/>
              </a:ext>
            </a:extLst>
          </a:blip>
          <a:stretch>
            <a:fillRect/>
          </a:stretch>
        </p:blipFill>
        <p:spPr>
          <a:xfrm>
            <a:off x="1554862" y="219887"/>
            <a:ext cx="8852639" cy="466045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71CD090B-5E6E-E739-9E57-F349E54A780F}"/>
              </a:ext>
            </a:extLst>
          </p:cNvPr>
          <p:cNvSpPr txBox="1"/>
          <p:nvPr/>
        </p:nvSpPr>
        <p:spPr>
          <a:xfrm>
            <a:off x="2013097" y="5039833"/>
            <a:ext cx="816580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Supplementary Fig. 5 The histogram of the Rad-score based on the selected features.</a:t>
            </a:r>
            <a:endParaRPr lang="en-CN" dirty="0"/>
          </a:p>
        </p:txBody>
      </p:sp>
    </p:spTree>
    <p:extLst>
      <p:ext uri="{BB962C8B-B14F-4D97-AF65-F5344CB8AC3E}">
        <p14:creationId xmlns:p14="http://schemas.microsoft.com/office/powerpoint/2010/main" val="1130403120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A comparison of a diagram&#10;&#10;Description automatically generated with medium confidence">
            <a:extLst>
              <a:ext uri="{FF2B5EF4-FFF2-40B4-BE49-F238E27FC236}">
                <a16:creationId xmlns:a16="http://schemas.microsoft.com/office/drawing/2014/main" id="{256CDC97-B404-0468-EC8A-3ED1C3734D0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2468" y="101060"/>
            <a:ext cx="3674834" cy="6348869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E1C731E4-FA76-637C-5B55-61C2F15A647F}"/>
              </a:ext>
            </a:extLst>
          </p:cNvPr>
          <p:cNvSpPr txBox="1"/>
          <p:nvPr/>
        </p:nvSpPr>
        <p:spPr>
          <a:xfrm>
            <a:off x="5254145" y="4289243"/>
            <a:ext cx="5843587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Supplementary Fig.6 A) Radiomics models’ AUCs on the validation cohort; B) Clinical models’ AUCs on the validation cohort. LR: logistic regression; SVM: support vector machine; KNN: K-nearest Neighbors;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XGboost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: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eXtreme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 Gradient; </a:t>
            </a:r>
            <a:r>
              <a:rPr lang="en-US" sz="1800" kern="100" dirty="0" err="1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LightGBM</a:t>
            </a:r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: Light Gradient Boosting Machine; MLP: multi-layer perceptron.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0174961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5EB5841F-7362-DDA9-D28D-E160ACF51EF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64437" y="543810"/>
            <a:ext cx="6708088" cy="4558027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A2D53745-3223-7AF5-D44E-D8DC1871D5F7}"/>
              </a:ext>
            </a:extLst>
          </p:cNvPr>
          <p:cNvSpPr txBox="1"/>
          <p:nvPr/>
        </p:nvSpPr>
        <p:spPr>
          <a:xfrm>
            <a:off x="2387009" y="5343858"/>
            <a:ext cx="6943725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800" kern="100" dirty="0">
                <a:effectLst/>
                <a:latin typeface="Times New Roman" panose="02020603050405020304" pitchFamily="18" charset="0"/>
                <a:ea typeface="Songti SC Light" panose="02010600040101010101" pitchFamily="2" charset="-122"/>
                <a:cs typeface="Times New Roman" panose="02020603050405020304" pitchFamily="18" charset="0"/>
              </a:rPr>
              <a:t>Supplementary Fig.7  A) Univariable analysis shows that gender (male) and ACR-TIRADS scores are significantly related to malignancy. B) Multivariable analysis shows the Odds Ratio (OR) of gender (male) and ACR-TIRADS scores.</a:t>
            </a:r>
            <a:endParaRPr lang="en-CN" sz="1800" kern="100" dirty="0">
              <a:effectLst/>
              <a:latin typeface="DengXian" panose="02010600030101010101" pitchFamily="2" charset="-122"/>
              <a:ea typeface="DengXian" panose="02010600030101010101" pitchFamily="2" charset="-122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11925436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296</Words>
  <Application>Microsoft Macintosh PowerPoint</Application>
  <PresentationFormat>Widescreen</PresentationFormat>
  <Paragraphs>10</Paragraphs>
  <Slides>7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7</vt:i4>
      </vt:variant>
    </vt:vector>
  </HeadingPairs>
  <TitlesOfParts>
    <vt:vector size="13" baseType="lpstr">
      <vt:lpstr>DengXian</vt:lpstr>
      <vt:lpstr>Aptos</vt:lpstr>
      <vt:lpstr>Aptos Display</vt:lpstr>
      <vt:lpstr>Arial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ffice</dc:creator>
  <cp:lastModifiedBy>office</cp:lastModifiedBy>
  <cp:revision>1</cp:revision>
  <dcterms:created xsi:type="dcterms:W3CDTF">2025-02-24T13:04:59Z</dcterms:created>
  <dcterms:modified xsi:type="dcterms:W3CDTF">2025-02-24T13:12:10Z</dcterms:modified>
</cp:coreProperties>
</file>